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2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0441090" y="1077807"/>
            <a:ext cx="23423542" cy="9327836"/>
            <a:chOff x="6698430" y="1566902"/>
            <a:chExt cx="23423542" cy="9327836"/>
          </a:xfrm>
        </p:grpSpPr>
        <p:pic>
          <p:nvPicPr>
            <p:cNvPr id="5" name="图片 4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750795" y="5422537"/>
              <a:ext cx="5400000" cy="5400000"/>
            </a:xfrm>
            <a:prstGeom prst="rect">
              <a:avLst/>
            </a:prstGeom>
          </p:spPr>
        </p:pic>
        <p:pic>
          <p:nvPicPr>
            <p:cNvPr id="6" name="图片 5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250480" y="5422537"/>
              <a:ext cx="5400000" cy="5400000"/>
            </a:xfrm>
            <a:prstGeom prst="rect">
              <a:avLst/>
            </a:prstGeom>
          </p:spPr>
        </p:pic>
        <p:pic>
          <p:nvPicPr>
            <p:cNvPr id="7" name="图片 6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303983" y="5422537"/>
              <a:ext cx="5400000" cy="540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698430" y="5494738"/>
              <a:ext cx="5400000" cy="5400000"/>
            </a:xfrm>
            <a:prstGeom prst="rect">
              <a:avLst/>
            </a:prstGeom>
          </p:spPr>
        </p:pic>
        <p:sp>
          <p:nvSpPr>
            <p:cNvPr id="9" name="矩形 8"/>
            <p:cNvSpPr/>
            <p:nvPr/>
          </p:nvSpPr>
          <p:spPr>
            <a:xfrm rot="18900000">
              <a:off x="14367208" y="3571664"/>
              <a:ext cx="2662908" cy="11079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6600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Δ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 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8900000">
              <a:off x="24416564" y="1566902"/>
              <a:ext cx="5705408" cy="2123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∆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/</a:t>
              </a:r>
            </a:p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pXC</a:t>
              </a:r>
              <a:r>
                <a:rPr lang="en-US" altLang="zh-CN" sz="6600" i="1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colR</a:t>
              </a:r>
              <a:r>
                <a:rPr lang="en-US" altLang="zh-CN" sz="6600" i="1" baseline="-250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XOCgx_4037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8900000">
              <a:off x="19094875" y="1570079"/>
              <a:ext cx="5668539" cy="2123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∆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/</a:t>
              </a:r>
            </a:p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pXC</a:t>
              </a:r>
              <a:r>
                <a:rPr lang="en-US" altLang="zh-CN" sz="6600" i="1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colS</a:t>
              </a:r>
              <a:r>
                <a:rPr lang="en-US" altLang="zh-CN" sz="6600" i="1" baseline="-250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XOCgx_4036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8900000">
              <a:off x="8839868" y="3729272"/>
              <a:ext cx="2153154" cy="11079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GX 01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10447094" y="11135767"/>
            <a:ext cx="23274680" cy="8972412"/>
            <a:chOff x="8259096" y="16145936"/>
            <a:chExt cx="23274680" cy="8972412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6"/>
            <a:srcRect l="8495" t="13296" r="8821" b="15443"/>
            <a:stretch/>
          </p:blipFill>
          <p:spPr>
            <a:xfrm>
              <a:off x="8259096" y="19956412"/>
              <a:ext cx="22005553" cy="5161936"/>
            </a:xfrm>
            <a:prstGeom prst="rect">
              <a:avLst/>
            </a:prstGeom>
          </p:spPr>
        </p:pic>
        <p:sp>
          <p:nvSpPr>
            <p:cNvPr id="13" name="矩形 12"/>
            <p:cNvSpPr/>
            <p:nvPr/>
          </p:nvSpPr>
          <p:spPr>
            <a:xfrm rot="18900000">
              <a:off x="10802430" y="18272219"/>
              <a:ext cx="2153154" cy="11079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</a:rPr>
                <a:t>GX 01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8900000">
              <a:off x="15491448" y="18154973"/>
              <a:ext cx="2662908" cy="11079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6600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Δ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 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8900000">
              <a:off x="25828368" y="16145936"/>
              <a:ext cx="5705408" cy="2123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∆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/</a:t>
              </a:r>
            </a:p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pXC</a:t>
              </a:r>
              <a:r>
                <a:rPr lang="en-US" altLang="zh-CN" sz="6600" i="1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colR</a:t>
              </a:r>
              <a:r>
                <a:rPr lang="en-US" altLang="zh-CN" sz="6600" i="1" baseline="-250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XOCgx_4037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8900000">
              <a:off x="20496293" y="16239389"/>
              <a:ext cx="5668539" cy="2123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∆</a:t>
              </a:r>
              <a:r>
                <a:rPr lang="en-US" altLang="zh-CN" sz="6600" i="1" dirty="0" err="1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emvR</a:t>
              </a:r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/</a:t>
              </a:r>
            </a:p>
            <a:p>
              <a:pPr algn="ctr"/>
              <a:r>
                <a:rPr lang="en-US" altLang="zh-CN" sz="66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pXC</a:t>
              </a:r>
              <a:r>
                <a:rPr lang="en-US" altLang="zh-CN" sz="6600" i="1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colS</a:t>
              </a:r>
              <a:r>
                <a:rPr lang="en-US" altLang="zh-CN" sz="6600" i="1" baseline="-25000" dirty="0">
                  <a:solidFill>
                    <a:srgbClr val="000000"/>
                  </a:solidFill>
                  <a:latin typeface="Arial Narrow" panose="020B0606020202030204" pitchFamily="34" charset="0"/>
                  <a:ea typeface="宋体" panose="02010600030101010101" pitchFamily="2" charset="-122"/>
                </a:rPr>
                <a:t>XOCgx_4036</a:t>
              </a:r>
              <a:endParaRPr lang="zh-CN" altLang="en-US" sz="66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20" name="矩形 19"/>
          <p:cNvSpPr/>
          <p:nvPr/>
        </p:nvSpPr>
        <p:spPr>
          <a:xfrm>
            <a:off x="9750385" y="3852594"/>
            <a:ext cx="652743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dirty="0">
                <a:solidFill>
                  <a:prstClr val="black"/>
                </a:solidFill>
                <a:latin typeface="Arial Narrow" panose="020B0606020202030204" pitchFamily="34" charset="0"/>
              </a:rPr>
              <a:t>a</a:t>
            </a:r>
            <a:endParaRPr lang="zh-CN" altLang="en-US" sz="8000" dirty="0"/>
          </a:p>
        </p:txBody>
      </p:sp>
      <p:sp>
        <p:nvSpPr>
          <p:cNvPr id="21" name="矩形 20"/>
          <p:cNvSpPr/>
          <p:nvPr/>
        </p:nvSpPr>
        <p:spPr>
          <a:xfrm>
            <a:off x="9759710" y="13864855"/>
            <a:ext cx="652743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dirty="0">
                <a:solidFill>
                  <a:prstClr val="black"/>
                </a:solidFill>
                <a:latin typeface="Arial Narrow" panose="020B0606020202030204" pitchFamily="34" charset="0"/>
              </a:rPr>
              <a:t>b</a:t>
            </a:r>
            <a:endParaRPr lang="zh-CN" altLang="en-US" sz="8000" dirty="0"/>
          </a:p>
        </p:txBody>
      </p:sp>
      <p:sp>
        <p:nvSpPr>
          <p:cNvPr id="19" name="矩形 18"/>
          <p:cNvSpPr/>
          <p:nvPr/>
        </p:nvSpPr>
        <p:spPr>
          <a:xfrm>
            <a:off x="1965998" y="21598063"/>
            <a:ext cx="39783581" cy="102489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5 Overexpression of the 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S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6</a:t>
            </a:r>
            <a:r>
              <a:rPr lang="en-US" altLang="zh-CN" sz="6600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or 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R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7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gene in the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eletion mutant can not restore its spreading motility and EPS production. Two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icrolitres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of culture suspensions (10</a:t>
            </a:r>
            <a:r>
              <a:rPr lang="en-US" altLang="zh-CN" sz="6600" kern="100" baseline="30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 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fu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/ml) of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ld-type strain GX01,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deletion mutant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and cross-complemented strains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/pXC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S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6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/pXC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R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7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ere inoculated onto “spreading” plates (a) and NA plates containing 2% sucrose (b), respectively, and incubated for 5 days at 28 °C. The strains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/pXC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S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6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/pXC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olR</a:t>
            </a:r>
            <a:r>
              <a:rPr lang="en-US" altLang="zh-CN" sz="6600" i="1" kern="100" baseline="-250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gx_4037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isplayed similar colonizes to the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mutant. </a:t>
            </a:r>
            <a:endParaRPr lang="zh-CN" altLang="zh-CN" sz="5400" kern="100" dirty="0">
              <a:effectLst/>
              <a:latin typeface="Arial Narrow" panose="020B0606020202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5005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6</TotalTime>
  <Words>156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 Narrow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41</cp:revision>
  <dcterms:created xsi:type="dcterms:W3CDTF">2024-03-09T05:50:12Z</dcterms:created>
  <dcterms:modified xsi:type="dcterms:W3CDTF">2025-03-20T09:54:40Z</dcterms:modified>
</cp:coreProperties>
</file>